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9144000" cy="6858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47294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890441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34716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8626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80054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192782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477872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19024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1045465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1655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22923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70233-DF1E-412E-B1C0-D3DF63DB0B8C}" type="datetimeFigureOut">
              <a:rPr lang="en-US" smtClean="0"/>
              <a:pPr/>
              <a:t>6/1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5EEEB-9A43-4E42-8013-07ED6A396B9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69351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295400" y="1288197"/>
            <a:ext cx="6999288" cy="3584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1295400" y="457200"/>
            <a:ext cx="699928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/>
                <a:ea typeface="Times New Roman"/>
              </a:rPr>
              <a:t>Additional file </a:t>
            </a:r>
            <a:r>
              <a:rPr lang="en-US" sz="1200" b="1" dirty="0" smtClean="0">
                <a:latin typeface="Times New Roman"/>
                <a:ea typeface="Times New Roman"/>
              </a:rPr>
              <a:t>11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 level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RPK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halose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synthesis gen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fou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-apical internodes (Int1-Int4) of bioenergy sorghum inbred R.07020. Int1 is the youngest internode below the shoot apex and Int4 is the oldest lower internode. Each value represen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KM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three biological replicat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expression level in each row highlighted with blue is lower and highlighted with red is higher. </a:t>
            </a:r>
            <a:endParaRPr lang="en-US" sz="120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588361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5</TotalTime>
  <Words>7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Kebrom</dc:creator>
  <cp:lastModifiedBy>0012761</cp:lastModifiedBy>
  <cp:revision>83</cp:revision>
  <cp:lastPrinted>2016-04-06T22:28:19Z</cp:lastPrinted>
  <dcterms:created xsi:type="dcterms:W3CDTF">2015-10-14T15:29:02Z</dcterms:created>
  <dcterms:modified xsi:type="dcterms:W3CDTF">2017-06-15T02:46:10Z</dcterms:modified>
</cp:coreProperties>
</file>